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89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EC80E-80FE-D44E-A4E0-294DF47291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CB061D-A913-4544-96FA-67CF705C6C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D5165B-E2D2-D44A-B608-0A8C6EAB5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5BE6F2-E8FC-D049-9C46-A43F23CFC5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724782-2A2B-E744-BD81-E1AC94698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786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A4BA73-7DB9-EC4B-B07D-D590C1CBD7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062A53-7FA3-B14F-9EA7-D306F46B27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83403B-D122-0148-8CAD-A317615B6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80B6FF-3D51-CC41-8D8D-802061A46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41B891-C148-314B-8E18-D3294A0FAF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018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F1C89C-57F0-2C45-8E67-7CECBD0A03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E79945-C2E3-314A-A3B8-8B4A612016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E4C6F3-E162-0C43-B998-9C530C606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BF666-D2A0-8E4D-A069-92C1711E63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88D639-A37C-A74D-96C9-1722D73AD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205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4F7CC-F226-894C-8ABE-AF55606055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69F0AF-7F46-4444-BF0B-C136788E3D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ACA61-07FB-624F-A5EB-AB43C0571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146772-E76B-7C4D-A9AC-5F10D3110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6EDAF-7E00-164A-A937-2EE1AD895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503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7C008C-F863-B443-B01C-30FB6B9E54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016D70-4464-9042-AEDA-314DE588CD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CA4B02-9958-3447-A430-7EF606378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0AB5BD-A8E1-A54C-A84E-9EFA8E539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F6B0C7-6D1D-3240-8188-154AFE29E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237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5B326-2AE3-354F-A7D3-E3B3D6C5B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C37661-99A6-5C43-8D02-A0271E12CA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F9BA87-CFA6-F341-9A3E-82058BA4E1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842B9A-5B3F-4E43-AF7E-44C2EA536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C09F3C-BC15-F249-8F6A-8746874B0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E3BC0D-2907-AA49-97AA-407A7F690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368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34B0F-19D7-5749-89F7-1225357074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C9246F-79BB-2B49-BC85-FF2C057298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37F0DF-1286-024E-BF68-8FE89BB86F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4B658A-62AA-B644-ACAD-C076EE0248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E5C1D2-B1F3-B44B-AA79-8460420309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7AB935-EFF3-6B48-9DA6-4E8A2698F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284DB9-8A5F-C74A-AC58-8F262F45E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6E3D78-FB64-3844-BB55-FD09FC3209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946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C8BB3-8D3F-9B41-ADB4-59B46FE4B9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BC14CC-C53C-3C4C-AF79-D1B9CDD2B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BC88DA-BFA0-D54C-914B-42B861398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E1F2EC-3AC6-0F46-AF98-64B6EBB1A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763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137997-4B25-8A4A-BEE5-EDCDB202B4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4745A9-BC3E-D74A-9989-A6076F23A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07AFC2-7FA2-8645-BD88-867D6C530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705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3CBF3-37DB-F14E-905D-0D37EA2983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582AEC-5D2B-4E43-BF2F-B8DFB439E6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B9D74B-CC57-6B48-A0AF-E3C61675EB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41DCFC-061B-394A-AC28-08855AC84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A72185-D6D0-0742-B9B8-E559264F5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F07665-0500-AE43-A4F8-0AFE24647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756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DC3CE5-1481-274A-A9E1-3FCA97E1EB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0E0586-EFF4-8246-A217-25279F31E6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0E9730-1B04-E643-9D51-1BE3CB1F76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98B6CD-1DE5-F344-9935-D5EC901DB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448541-D955-CA41-A9FE-E5BB67EDE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378162-EA5C-0F41-B98E-8BEBB93BB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194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34AD0E-726B-9443-9B82-42589A09A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06FEF-C00D-ED45-906E-56BB7A71F4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599583-D19F-6741-A38A-7096A73F43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79E9C-D3AD-D64D-B70A-D6B060FE2421}" type="datetimeFigureOut">
              <a:rPr lang="en-US" smtClean="0"/>
              <a:t>6/19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DB7070-0905-5145-8E64-53A4A86E6F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7546F6-06C3-3D4A-A6B0-044D6F4180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4C8A5-93FA-2A45-826D-E77DC7420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10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7102147-2B25-FD4B-AB7B-AE6FB1F779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9600423"/>
              </p:ext>
            </p:extLst>
          </p:nvPr>
        </p:nvGraphicFramePr>
        <p:xfrm>
          <a:off x="3957391" y="1414011"/>
          <a:ext cx="5152919" cy="571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Equation" r:id="rId3" imgW="1828800" imgH="203200" progId="Equation.DSMT4">
                  <p:embed/>
                </p:oleObj>
              </mc:Choice>
              <mc:Fallback>
                <p:oleObj name="Equation" r:id="rId3" imgW="1828800" imgH="203200" progId="Equation.DSMT4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0392AF72-593E-EA46-A81A-08B1F6CFC8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57391" y="1414011"/>
                        <a:ext cx="5152919" cy="571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9188A9E-A4E1-A840-8F5C-2A35BECD5A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7354383"/>
              </p:ext>
            </p:extLst>
          </p:nvPr>
        </p:nvGraphicFramePr>
        <p:xfrm>
          <a:off x="663082" y="678077"/>
          <a:ext cx="11224117" cy="55442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30492">
                  <a:extLst>
                    <a:ext uri="{9D8B030D-6E8A-4147-A177-3AD203B41FA5}">
                      <a16:colId xmlns:a16="http://schemas.microsoft.com/office/drawing/2014/main" val="3550158705"/>
                    </a:ext>
                  </a:extLst>
                </a:gridCol>
                <a:gridCol w="7993625">
                  <a:extLst>
                    <a:ext uri="{9D8B030D-6E8A-4147-A177-3AD203B41FA5}">
                      <a16:colId xmlns:a16="http://schemas.microsoft.com/office/drawing/2014/main" val="89210428"/>
                    </a:ext>
                  </a:extLst>
                </a:gridCol>
              </a:tblGrid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chastic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ical Master Equ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7959470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rth-dea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780876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ng Allee on bir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5004672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ng Allee on dea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041972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ong Allee on birth &amp; dea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400386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ak Allee on bir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4170718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ak Allee on dea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8844373"/>
                  </a:ext>
                </a:extLst>
              </a:tr>
              <a:tr h="693031"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ak Allee on birth &amp; death mode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298219"/>
                  </a:ext>
                </a:extLst>
              </a:tr>
            </a:tbl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DC71B2FC-C4B4-1140-A6D0-A06D35C5F4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9561728"/>
              </p:ext>
            </p:extLst>
          </p:nvPr>
        </p:nvGraphicFramePr>
        <p:xfrm>
          <a:off x="3957391" y="2880658"/>
          <a:ext cx="5890468" cy="4749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Equation" r:id="rId5" imgW="2527300" imgH="203200" progId="Equation.DSMT4">
                  <p:embed/>
                </p:oleObj>
              </mc:Choice>
              <mc:Fallback>
                <p:oleObj name="Equation" r:id="rId5" imgW="2527300" imgH="203200" progId="Equation.DSMT4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8CA619D-94E0-894A-9802-7F80D69719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57391" y="2880658"/>
                        <a:ext cx="5890468" cy="47494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A91CC36-FAC8-EF49-BC12-A3F3C0A635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8731536"/>
              </p:ext>
            </p:extLst>
          </p:nvPr>
        </p:nvGraphicFramePr>
        <p:xfrm>
          <a:off x="3889453" y="2141115"/>
          <a:ext cx="6440658" cy="5162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Equation" r:id="rId7" imgW="2527300" imgH="203200" progId="Equation.DSMT4">
                  <p:embed/>
                </p:oleObj>
              </mc:Choice>
              <mc:Fallback>
                <p:oleObj name="Equation" r:id="rId7" imgW="2527300" imgH="203200" progId="Equation.DSMT4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9E28F965-EAAF-5D40-8D93-1D447D83C3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89453" y="2141115"/>
                        <a:ext cx="6440658" cy="5162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A04BC13-37C0-8B41-994C-CB21E103EE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3267495"/>
              </p:ext>
            </p:extLst>
          </p:nvPr>
        </p:nvGraphicFramePr>
        <p:xfrm>
          <a:off x="3973750" y="3542223"/>
          <a:ext cx="6690753" cy="5237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Equation" r:id="rId9" imgW="2603500" imgH="203200" progId="Equation.DSMT4">
                  <p:embed/>
                </p:oleObj>
              </mc:Choice>
              <mc:Fallback>
                <p:oleObj name="Equation" r:id="rId9" imgW="2603500" imgH="203200" progId="Equation.DSMT4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1C9FBB63-FCF9-3B48-BE02-62AA08EC59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73750" y="3542223"/>
                        <a:ext cx="6690753" cy="5237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693B9384-E2E7-C641-A391-3799361A7C6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5258217"/>
              </p:ext>
            </p:extLst>
          </p:nvPr>
        </p:nvGraphicFramePr>
        <p:xfrm>
          <a:off x="4007656" y="4296990"/>
          <a:ext cx="6204252" cy="412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Equation" r:id="rId11" imgW="3251200" imgH="215900" progId="Equation.DSMT4">
                  <p:embed/>
                </p:oleObj>
              </mc:Choice>
              <mc:Fallback>
                <p:oleObj name="Equation" r:id="rId11" imgW="3251200" imgH="215900" progId="Equation.DSMT4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13535AFA-555B-AF41-8A6E-9E8323CD68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07656" y="4296990"/>
                        <a:ext cx="6204252" cy="412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CEB56EE5-A144-8140-8951-3EC94E7A41D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0933074"/>
              </p:ext>
            </p:extLst>
          </p:nvPr>
        </p:nvGraphicFramePr>
        <p:xfrm>
          <a:off x="3934134" y="5619106"/>
          <a:ext cx="7780341" cy="4810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Equation" r:id="rId13" imgW="3492500" imgH="215900" progId="Equation.DSMT4">
                  <p:embed/>
                </p:oleObj>
              </mc:Choice>
              <mc:Fallback>
                <p:oleObj name="Equation" r:id="rId13" imgW="3492500" imgH="215900" progId="Equation.DSMT4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CBF7674F-F49E-C746-83D1-89F377A988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34134" y="5619106"/>
                        <a:ext cx="7780341" cy="4810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14A943F8-EDB0-B947-8C6C-077D4DF836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2109242"/>
              </p:ext>
            </p:extLst>
          </p:nvPr>
        </p:nvGraphicFramePr>
        <p:xfrm>
          <a:off x="4007656" y="4901493"/>
          <a:ext cx="7541990" cy="5175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Equation" r:id="rId15" imgW="3149600" imgH="215900" progId="Equation.DSMT4">
                  <p:embed/>
                </p:oleObj>
              </mc:Choice>
              <mc:Fallback>
                <p:oleObj name="Equation" r:id="rId15" imgW="3149600" imgH="215900" progId="Equation.DSMT4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9E3A0745-3F01-6C4A-A5E1-D27A57CC22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007656" y="4901493"/>
                        <a:ext cx="7541990" cy="5175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10237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1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Equ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Kaitlyn</dc:creator>
  <cp:lastModifiedBy>Johnson, Kaitlyn</cp:lastModifiedBy>
  <cp:revision>1</cp:revision>
  <dcterms:created xsi:type="dcterms:W3CDTF">2019-06-13T21:49:01Z</dcterms:created>
  <dcterms:modified xsi:type="dcterms:W3CDTF">2019-06-19T22:16:12Z</dcterms:modified>
</cp:coreProperties>
</file>